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56" r:id="rId2"/>
    <p:sldId id="278" r:id="rId3"/>
    <p:sldId id="263" r:id="rId4"/>
    <p:sldId id="282" r:id="rId5"/>
    <p:sldId id="287" r:id="rId6"/>
    <p:sldId id="284" r:id="rId7"/>
    <p:sldId id="289" r:id="rId8"/>
    <p:sldId id="286" r:id="rId9"/>
    <p:sldId id="269" r:id="rId10"/>
    <p:sldId id="288" r:id="rId11"/>
    <p:sldId id="285" r:id="rId12"/>
    <p:sldId id="290" r:id="rId13"/>
    <p:sldId id="291" r:id="rId1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r jothi lakshmi" initials="Djl" lastIdx="5" clrIdx="0">
    <p:extLst>
      <p:ext uri="{19B8F6BF-5375-455C-9EA6-DF929625EA0E}">
        <p15:presenceInfo xmlns:p15="http://schemas.microsoft.com/office/powerpoint/2012/main" userId="Dr jothi lakshmi" providerId="None"/>
      </p:ext>
    </p:extLst>
  </p:cmAuthor>
  <p:cmAuthor id="2" name="USER" initials="U" lastIdx="3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443" autoAdjust="0"/>
    <p:restoredTop sz="94660"/>
  </p:normalViewPr>
  <p:slideViewPr>
    <p:cSldViewPr>
      <p:cViewPr varScale="1">
        <p:scale>
          <a:sx n="84" d="100"/>
          <a:sy n="84" d="100"/>
        </p:scale>
        <p:origin x="3336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image" Target="../media/image2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image" Target="../media/image6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wmf"/><Relationship Id="rId1" Type="http://schemas.openxmlformats.org/officeDocument/2006/relationships/image" Target="../media/image9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w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wmf"/><Relationship Id="rId2" Type="http://schemas.openxmlformats.org/officeDocument/2006/relationships/image" Target="../media/image16.wmf"/><Relationship Id="rId1" Type="http://schemas.openxmlformats.org/officeDocument/2006/relationships/image" Target="../media/image15.w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31.wmf"/><Relationship Id="rId2" Type="http://schemas.openxmlformats.org/officeDocument/2006/relationships/image" Target="../media/image30.wmf"/><Relationship Id="rId1" Type="http://schemas.openxmlformats.org/officeDocument/2006/relationships/image" Target="../media/image29.w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33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7447E2-3227-497C-905F-0548C84CBBD4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5FB207-51D7-4A6F-9008-96391503DC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695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5FB207-51D7-4A6F-9008-96391503DCB9}" type="slidenum">
              <a:rPr lang="en-US" smtClean="0"/>
              <a:pPr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7769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720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286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251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082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507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663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774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907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811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411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2476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1B1039-A74E-4462-B75A-DF599A296603}" type="datetimeFigureOut">
              <a:rPr lang="en-US" smtClean="0"/>
              <a:pPr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17FD1-736E-4A60-A464-2204B86BDB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8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image" Target="../media/image19.png"/><Relationship Id="rId7" Type="http://schemas.microsoft.com/office/2007/relationships/hdphoto" Target="../media/hdphoto2.wdp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jpeg"/><Relationship Id="rId9" Type="http://schemas.openxmlformats.org/officeDocument/2006/relationships/image" Target="../media/image24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eg"/><Relationship Id="rId3" Type="http://schemas.microsoft.com/office/2007/relationships/hdphoto" Target="../media/hdphoto3.wdp"/><Relationship Id="rId7" Type="http://schemas.microsoft.com/office/2007/relationships/hdphoto" Target="../media/hdphoto5.wdp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jpeg"/><Relationship Id="rId5" Type="http://schemas.microsoft.com/office/2007/relationships/hdphoto" Target="../media/hdphoto4.wdp"/><Relationship Id="rId4" Type="http://schemas.openxmlformats.org/officeDocument/2006/relationships/image" Target="../media/image26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wmf"/><Relationship Id="rId3" Type="http://schemas.openxmlformats.org/officeDocument/2006/relationships/oleObject" Target="../embeddings/oleObject11.bin"/><Relationship Id="rId7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microsoft.com/office/2007/relationships/hdphoto" Target="../media/hdphoto6.wdp"/><Relationship Id="rId5" Type="http://schemas.openxmlformats.org/officeDocument/2006/relationships/image" Target="../media/image32.jpeg"/><Relationship Id="rId10" Type="http://schemas.openxmlformats.org/officeDocument/2006/relationships/image" Target="../media/image31.wmf"/><Relationship Id="rId4" Type="http://schemas.openxmlformats.org/officeDocument/2006/relationships/image" Target="../media/image29.wmf"/><Relationship Id="rId9" Type="http://schemas.openxmlformats.org/officeDocument/2006/relationships/oleObject" Target="../embeddings/oleObject13.bin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3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34.png"/><Relationship Id="rId5" Type="http://schemas.openxmlformats.org/officeDocument/2006/relationships/image" Target="../media/image33.wmf"/><Relationship Id="rId4" Type="http://schemas.openxmlformats.org/officeDocument/2006/relationships/oleObject" Target="../embeddings/oleObject14.bin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7" Type="http://schemas.openxmlformats.org/officeDocument/2006/relationships/image" Target="../media/image3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2.w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7" Type="http://schemas.openxmlformats.org/officeDocument/2006/relationships/image" Target="../media/image8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w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6.w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oleObject" Target="../embeddings/oleObject5.bin"/><Relationship Id="rId7" Type="http://schemas.openxmlformats.org/officeDocument/2006/relationships/image" Target="../media/image1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0.w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9.w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14.w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w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6.w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15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3400" y="304800"/>
            <a:ext cx="5829300" cy="3124200"/>
          </a:xfrm>
        </p:spPr>
        <p:txBody>
          <a:bodyPr>
            <a:normAutofit fontScale="90000"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sz="2400" dirty="0">
                <a:latin typeface="Times New Roman" pitchFamily="18" charset="0"/>
                <a:cs typeface="Times New Roman" pitchFamily="18" charset="0"/>
              </a:rPr>
            </a:br>
            <a:r>
              <a:rPr lang="en-US" sz="24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sz="2400" dirty="0">
                <a:latin typeface="Times New Roman" pitchFamily="18" charset="0"/>
                <a:cs typeface="Times New Roman" pitchFamily="18" charset="0"/>
              </a:rPr>
            </a:b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Supporting Information for</a:t>
            </a:r>
            <a:br>
              <a:rPr lang="en-US" sz="1600" dirty="0">
                <a:latin typeface="Times New Roman" pitchFamily="18" charset="0"/>
                <a:cs typeface="Times New Roman" pitchFamily="18" charset="0"/>
              </a:rPr>
            </a:b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sz="1600" dirty="0">
                <a:latin typeface="Times New Roman" pitchFamily="18" charset="0"/>
                <a:cs typeface="Times New Roman" pitchFamily="18" charset="0"/>
              </a:rPr>
            </a:br>
            <a:r>
              <a:rPr lang="en-US" sz="1600" i="1" dirty="0">
                <a:latin typeface="Times New Roman" pitchFamily="18" charset="0"/>
                <a:cs typeface="Times New Roman" pitchFamily="18" charset="0"/>
              </a:rPr>
              <a:t>Piriformospora indica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employs host’s putrescine</a:t>
            </a:r>
            <a:r>
              <a:rPr lang="en-US" sz="16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for growth promotion in plants </a:t>
            </a:r>
            <a:br>
              <a:rPr lang="en-US" sz="1600" dirty="0">
                <a:latin typeface="Times New Roman" pitchFamily="18" charset="0"/>
                <a:cs typeface="Times New Roman" pitchFamily="18" charset="0"/>
              </a:rPr>
            </a:b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sz="1600" dirty="0">
                <a:latin typeface="Times New Roman" pitchFamily="18" charset="0"/>
                <a:cs typeface="Times New Roman" pitchFamily="18" charset="0"/>
              </a:rPr>
            </a:b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Anish Kundu,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Abhimanyu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Jogawat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Shruti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Mishra,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Pritha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Kundu,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Jyothilakshmi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Vadassery*</a:t>
            </a:r>
            <a:br>
              <a:rPr lang="en-US" sz="1600" dirty="0">
                <a:latin typeface="Times New Roman" pitchFamily="18" charset="0"/>
                <a:cs typeface="Times New Roman" pitchFamily="18" charset="0"/>
              </a:rPr>
            </a:b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sz="1600" dirty="0">
                <a:latin typeface="Times New Roman" pitchFamily="18" charset="0"/>
                <a:cs typeface="Times New Roman" pitchFamily="18" charset="0"/>
              </a:rPr>
            </a:b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*Correspondence to:  jyothi.v@nipgr.ac.in</a:t>
            </a:r>
            <a:br>
              <a:rPr lang="en-US" sz="1600" dirty="0">
                <a:latin typeface="Times New Roman" pitchFamily="18" charset="0"/>
                <a:cs typeface="Times New Roman" pitchFamily="18" charset="0"/>
              </a:rPr>
            </a:b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sz="1600" dirty="0">
                <a:latin typeface="Times New Roman" pitchFamily="18" charset="0"/>
                <a:cs typeface="Times New Roman" pitchFamily="18" charset="0"/>
              </a:rPr>
            </a:b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784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Group 69"/>
          <p:cNvGrpSpPr/>
          <p:nvPr/>
        </p:nvGrpSpPr>
        <p:grpSpPr>
          <a:xfrm>
            <a:off x="381000" y="3666268"/>
            <a:ext cx="6134169" cy="4139142"/>
            <a:chOff x="495231" y="3013787"/>
            <a:chExt cx="6134169" cy="413914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36" t="1896" r="17823"/>
            <a:stretch/>
          </p:blipFill>
          <p:spPr bwMode="auto">
            <a:xfrm>
              <a:off x="2819400" y="3138792"/>
              <a:ext cx="1232358" cy="9111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" name="Group 4"/>
            <p:cNvGrpSpPr/>
            <p:nvPr/>
          </p:nvGrpSpPr>
          <p:grpSpPr>
            <a:xfrm>
              <a:off x="596442" y="3134766"/>
              <a:ext cx="1371600" cy="931653"/>
              <a:chOff x="3124200" y="2971800"/>
              <a:chExt cx="1905000" cy="1371600"/>
            </a:xfrm>
          </p:grpSpPr>
          <p:sp>
            <p:nvSpPr>
              <p:cNvPr id="4" name="Rounded Rectangle 3"/>
              <p:cNvSpPr/>
              <p:nvPr/>
            </p:nvSpPr>
            <p:spPr>
              <a:xfrm>
                <a:off x="3124200" y="2971800"/>
                <a:ext cx="1905000" cy="1371600"/>
              </a:xfrm>
              <a:prstGeom prst="round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3200400" y="3058101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1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3195368" y="3484532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2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3206151" y="3903453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3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3651849" y="3048000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4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3646817" y="3474431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5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3657600" y="3893352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6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4109049" y="3048000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7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4104017" y="3474431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8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4114800" y="3893352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9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4566249" y="3048000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20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4561217" y="3474431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21" name="Picture 8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38" t="22917" r="54189" b="33498"/>
              <a:stretch/>
            </p:blipFill>
            <p:spPr bwMode="auto">
              <a:xfrm>
                <a:off x="4572000" y="3893352"/>
                <a:ext cx="381000" cy="346135"/>
              </a:xfrm>
              <a:prstGeom prst="roundRect">
                <a:avLst>
                  <a:gd name="adj" fmla="val 16667"/>
                </a:avLst>
              </a:prstGeom>
              <a:ln w="38100">
                <a:solidFill>
                  <a:schemeClr val="tx1"/>
                </a:solidFill>
                <a:miter lim="800000"/>
                <a:headEnd/>
                <a:tailEnd/>
              </a:ln>
              <a:effectLst>
                <a:outerShdw blurRad="76200" dist="38100" dir="78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contrasting" dir="t">
                  <a:rot lat="0" lon="0" rev="4200000"/>
                </a:lightRig>
              </a:scene3d>
              <a:sp3d prstMaterial="plastic">
                <a:bevelT w="381000" h="114300" prst="relaxedInset"/>
                <a:contourClr>
                  <a:srgbClr val="969696"/>
                </a:contourClr>
              </a:sp3d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</p:grpSp>
        <p:grpSp>
          <p:nvGrpSpPr>
            <p:cNvPr id="34" name="Group 33"/>
            <p:cNvGrpSpPr/>
            <p:nvPr/>
          </p:nvGrpSpPr>
          <p:grpSpPr>
            <a:xfrm>
              <a:off x="4800600" y="3013787"/>
              <a:ext cx="1585572" cy="1069630"/>
              <a:chOff x="4800600" y="3121371"/>
              <a:chExt cx="1585572" cy="1069630"/>
            </a:xfrm>
          </p:grpSpPr>
          <p:pic>
            <p:nvPicPr>
              <p:cNvPr id="1035" name="Picture 11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094" t="15652" r="36259" b="25362"/>
              <a:stretch/>
            </p:blipFill>
            <p:spPr bwMode="auto">
              <a:xfrm>
                <a:off x="4800600" y="3121371"/>
                <a:ext cx="675556" cy="10696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36" name="Picture 12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47469" y="3283416"/>
                <a:ext cx="281342" cy="31031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5" name="Picture 13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ackgroundRemoval t="9091" b="96970" l="41014" r="5553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194" t="8811" r="45252" b="4232"/>
              <a:stretch/>
            </p:blipFill>
            <p:spPr bwMode="auto">
              <a:xfrm rot="3527454" flipH="1">
                <a:off x="5607863" y="2984289"/>
                <a:ext cx="244124" cy="13124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6" name="Picture 2" descr="D:\7.12.11\piri plate pic 15-03-12.jpg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44" t="11107" r="35416" b="18484"/>
              <a:stretch>
                <a:fillRect/>
              </a:stretch>
            </p:blipFill>
            <p:spPr bwMode="auto">
              <a:xfrm>
                <a:off x="5943600" y="3613178"/>
                <a:ext cx="308453" cy="271964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cxnSp>
          <p:nvCxnSpPr>
            <p:cNvPr id="60" name="Straight Arrow Connector 59"/>
            <p:cNvCxnSpPr/>
            <p:nvPr/>
          </p:nvCxnSpPr>
          <p:spPr>
            <a:xfrm flipV="1">
              <a:off x="2057400" y="3593113"/>
              <a:ext cx="685800" cy="123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/>
            <p:cNvCxnSpPr/>
            <p:nvPr/>
          </p:nvCxnSpPr>
          <p:spPr>
            <a:xfrm flipV="1">
              <a:off x="4191000" y="3593113"/>
              <a:ext cx="533400" cy="61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8" name="Straight Arrow Connector 1037"/>
            <p:cNvCxnSpPr/>
            <p:nvPr/>
          </p:nvCxnSpPr>
          <p:spPr>
            <a:xfrm>
              <a:off x="5528811" y="4546642"/>
              <a:ext cx="0" cy="33015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0" name="Straight Connector 1039"/>
            <p:cNvCxnSpPr/>
            <p:nvPr/>
          </p:nvCxnSpPr>
          <p:spPr>
            <a:xfrm>
              <a:off x="1309674" y="4876800"/>
              <a:ext cx="46339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2" name="Straight Arrow Connector 1041"/>
            <p:cNvCxnSpPr/>
            <p:nvPr/>
          </p:nvCxnSpPr>
          <p:spPr>
            <a:xfrm>
              <a:off x="1309674" y="4876800"/>
              <a:ext cx="0" cy="5334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4" name="Straight Arrow Connector 1043"/>
            <p:cNvCxnSpPr/>
            <p:nvPr/>
          </p:nvCxnSpPr>
          <p:spPr>
            <a:xfrm>
              <a:off x="3626637" y="4876800"/>
              <a:ext cx="0" cy="5334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Arrow Connector 85"/>
            <p:cNvCxnSpPr/>
            <p:nvPr/>
          </p:nvCxnSpPr>
          <p:spPr>
            <a:xfrm>
              <a:off x="5943600" y="4876800"/>
              <a:ext cx="0" cy="5334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5" name="TextBox 1044"/>
            <p:cNvSpPr txBox="1"/>
            <p:nvPr/>
          </p:nvSpPr>
          <p:spPr>
            <a:xfrm>
              <a:off x="495231" y="4084977"/>
              <a:ext cx="161335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eed sowing of Tomato (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olanum lycopersicum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) Variety :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us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ubi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019300" y="3121371"/>
              <a:ext cx="762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 weeks (14 days) post germination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4009468" y="3119735"/>
              <a:ext cx="9144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gro-Inoculation with TRV constructs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628900" y="4038600"/>
              <a:ext cx="16133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antlets with two cotyledonous leaves and two true leaves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191000" y="3962400"/>
              <a:ext cx="24384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gro-inoculation with needleless syringe on the abaxial leaf surface followed by application of </a:t>
              </a:r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iriformospora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indic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pore suspension in the soil surrounding the crown region of the plant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2806242" y="4661356"/>
              <a:ext cx="16133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 weeks post Agro-inoculation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244600" y="4991556"/>
              <a:ext cx="5314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et 1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3592406" y="4991556"/>
              <a:ext cx="5223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et 2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5901630" y="4991556"/>
              <a:ext cx="5753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et 3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495231" y="5417181"/>
              <a:ext cx="16133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mpty vector (TRV1+ TRV2)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785728" y="5423813"/>
              <a:ext cx="16133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lADC1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ilencing construct (TRV1+ TRV2: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lADC1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4800600" y="5406936"/>
              <a:ext cx="179873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lADC1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ilencing construct (TRV1+ TRV2: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lADC1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) followed by application of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. indic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pore suspension</a:t>
              </a:r>
            </a:p>
          </p:txBody>
        </p:sp>
        <p:cxnSp>
          <p:nvCxnSpPr>
            <p:cNvPr id="1049" name="Straight Arrow Connector 1048"/>
            <p:cNvCxnSpPr>
              <a:stCxn id="98" idx="2"/>
            </p:cNvCxnSpPr>
            <p:nvPr/>
          </p:nvCxnSpPr>
          <p:spPr>
            <a:xfrm>
              <a:off x="1301910" y="5632625"/>
              <a:ext cx="0" cy="35908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Arrow Connector 103"/>
            <p:cNvCxnSpPr/>
            <p:nvPr/>
          </p:nvCxnSpPr>
          <p:spPr>
            <a:xfrm>
              <a:off x="3628665" y="5762367"/>
              <a:ext cx="0" cy="22934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3" name="Straight Connector 1052"/>
            <p:cNvCxnSpPr/>
            <p:nvPr/>
          </p:nvCxnSpPr>
          <p:spPr>
            <a:xfrm>
              <a:off x="1301910" y="5991711"/>
              <a:ext cx="232675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Down Arrow 63"/>
            <p:cNvSpPr/>
            <p:nvPr/>
          </p:nvSpPr>
          <p:spPr>
            <a:xfrm>
              <a:off x="2465287" y="5991711"/>
              <a:ext cx="45719" cy="180489"/>
            </a:xfrm>
            <a:prstGeom prst="down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1439070" y="6172200"/>
              <a:ext cx="2047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firmation of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lADC1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ilencing in the root of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. lycopersicum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by RT-qPCR</a:t>
              </a:r>
            </a:p>
          </p:txBody>
        </p:sp>
        <p:cxnSp>
          <p:nvCxnSpPr>
            <p:cNvPr id="112" name="Straight Arrow Connector 111"/>
            <p:cNvCxnSpPr/>
            <p:nvPr/>
          </p:nvCxnSpPr>
          <p:spPr>
            <a:xfrm>
              <a:off x="997886" y="5623002"/>
              <a:ext cx="0" cy="10063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Arrow Connector 113"/>
            <p:cNvCxnSpPr/>
            <p:nvPr/>
          </p:nvCxnSpPr>
          <p:spPr>
            <a:xfrm>
              <a:off x="3733800" y="5753095"/>
              <a:ext cx="0" cy="87630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Arrow Connector 115"/>
            <p:cNvCxnSpPr/>
            <p:nvPr/>
          </p:nvCxnSpPr>
          <p:spPr>
            <a:xfrm>
              <a:off x="5713017" y="5973266"/>
              <a:ext cx="0" cy="65613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987759" y="6629400"/>
              <a:ext cx="47421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Down Arrow 119"/>
            <p:cNvSpPr/>
            <p:nvPr/>
          </p:nvSpPr>
          <p:spPr>
            <a:xfrm>
              <a:off x="3440695" y="6629400"/>
              <a:ext cx="45719" cy="180489"/>
            </a:xfrm>
            <a:prstGeom prst="down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651645" y="6814375"/>
              <a:ext cx="38245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henotypic analysis (e.g.: root growth assay)  for the identification of the role of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DC1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. indic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mediated root growth promotion in tomato</a:t>
              </a:r>
            </a:p>
          </p:txBody>
        </p:sp>
      </p:grpSp>
      <p:sp>
        <p:nvSpPr>
          <p:cNvPr id="124" name="TextBox 123"/>
          <p:cNvSpPr txBox="1"/>
          <p:nvPr/>
        </p:nvSpPr>
        <p:spPr>
          <a:xfrm>
            <a:off x="19956" y="3828313"/>
            <a:ext cx="462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4536" y="1023610"/>
            <a:ext cx="462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14137" y="7905049"/>
            <a:ext cx="6671064" cy="18697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 of the VIGS protocol in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anum lycopersicu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 unique  375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sequence from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AD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cloned into the TRV2 vector by using conventional restriction digestion based method which was further transformed into the GV3101 strai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robacteriu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weeks old plants post germination were inoculated with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robacteriu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ures containing the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AD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lencing construct or TRV2 (empty) vector along with TRV1 vector followed by application of spore suspens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riformospora indica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phenotypic analysis to be carried out 3 weeks post agro-inoculation.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175" y="795010"/>
            <a:ext cx="6321425" cy="261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1" name="TextBox 60"/>
          <p:cNvSpPr txBox="1"/>
          <p:nvPr/>
        </p:nvSpPr>
        <p:spPr>
          <a:xfrm>
            <a:off x="561481" y="426816"/>
            <a:ext cx="2614579" cy="315015"/>
          </a:xfrm>
          <a:prstGeom prst="rect">
            <a:avLst/>
          </a:prstGeom>
          <a:noFill/>
        </p:spPr>
        <p:txBody>
          <a:bodyPr wrap="square" lIns="98609" tIns="49304" rIns="98609" bIns="49304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9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94523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63155" y="4114800"/>
            <a:ext cx="6172200" cy="22159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10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VIGS confirmation in 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it-IT" sz="1200" i="1" dirty="0">
                <a:latin typeface="Times New Roman" pitchFamily="18" charset="0"/>
                <a:cs typeface="Times New Roman" pitchFamily="18" charset="0"/>
              </a:rPr>
              <a:t>lycopersicum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ymptom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developed in the plant at 14 days post agro-infiltration and persisted even at 45 days post agro-infiltration. Representative figure of the leaves from the plants infiltrated with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nly infiltration buffer,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mpty vector 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DS construct showing development of photo-bleaching symptoms. Whole plant view upon infiltration with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D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nly infiltration Buffer,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E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mpty vector 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F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DS construct showing development of photo-bleaching symptoms.</a:t>
            </a:r>
          </a:p>
          <a:p>
            <a:pPr algn="just"/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977604" y="1143000"/>
            <a:ext cx="5179872" cy="2667001"/>
            <a:chOff x="399031" y="1468692"/>
            <a:chExt cx="6059229" cy="3179508"/>
          </a:xfrm>
        </p:grpSpPr>
        <p:grpSp>
          <p:nvGrpSpPr>
            <p:cNvPr id="2" name="Group 1"/>
            <p:cNvGrpSpPr/>
            <p:nvPr/>
          </p:nvGrpSpPr>
          <p:grpSpPr>
            <a:xfrm>
              <a:off x="399031" y="1468692"/>
              <a:ext cx="6059229" cy="3179508"/>
              <a:chOff x="399031" y="1492456"/>
              <a:chExt cx="6059229" cy="3179508"/>
            </a:xfrm>
          </p:grpSpPr>
          <p:pic>
            <p:nvPicPr>
              <p:cNvPr id="10" name="Picture 3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9031" y="3369885"/>
                <a:ext cx="1920035" cy="130207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09931" y="3369886"/>
                <a:ext cx="1948329" cy="130207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2" name="Picture 6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47239" y="3369886"/>
                <a:ext cx="1920035" cy="130207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6" name="Group 15"/>
              <p:cNvGrpSpPr/>
              <p:nvPr/>
            </p:nvGrpSpPr>
            <p:grpSpPr>
              <a:xfrm>
                <a:off x="2018681" y="1492456"/>
                <a:ext cx="2491250" cy="1688952"/>
                <a:chOff x="433252" y="397255"/>
                <a:chExt cx="2491250" cy="1688952"/>
              </a:xfrm>
            </p:grpSpPr>
            <p:pic>
              <p:nvPicPr>
                <p:cNvPr id="4" name="Picture 2"/>
                <p:cNvPicPr>
                  <a:picLocks noChangeAspect="1" noChangeArrowheads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74414" y="457199"/>
                  <a:ext cx="2450088" cy="162900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6" name="TextBox 5"/>
                <p:cNvSpPr txBox="1"/>
                <p:nvPr/>
              </p:nvSpPr>
              <p:spPr>
                <a:xfrm>
                  <a:off x="433252" y="397255"/>
                  <a:ext cx="495300" cy="4403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>
                      <a:solidFill>
                        <a:schemeClr val="bg1"/>
                      </a:solidFill>
                    </a:rPr>
                    <a:t>A</a:t>
                  </a: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1274993" y="397255"/>
                  <a:ext cx="495300" cy="4403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</a:rPr>
                    <a:t>B</a:t>
                  </a: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2166353" y="397256"/>
                  <a:ext cx="495300" cy="4403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</a:rPr>
                    <a:t>C</a:t>
                  </a:r>
                </a:p>
              </p:txBody>
            </p:sp>
          </p:grpSp>
        </p:grpSp>
        <p:sp>
          <p:nvSpPr>
            <p:cNvPr id="13" name="TextBox 12"/>
            <p:cNvSpPr txBox="1"/>
            <p:nvPr/>
          </p:nvSpPr>
          <p:spPr>
            <a:xfrm>
              <a:off x="399031" y="3346787"/>
              <a:ext cx="495300" cy="4403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D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447238" y="3346121"/>
              <a:ext cx="495300" cy="4403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E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509931" y="3346787"/>
              <a:ext cx="495300" cy="4403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F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447180" y="457200"/>
            <a:ext cx="2614579" cy="315015"/>
          </a:xfrm>
          <a:prstGeom prst="rect">
            <a:avLst/>
          </a:prstGeom>
          <a:noFill/>
        </p:spPr>
        <p:txBody>
          <a:bodyPr wrap="square" lIns="98609" tIns="49304" rIns="98609" bIns="49304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10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53064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739708" y="381000"/>
            <a:ext cx="2614579" cy="315015"/>
          </a:xfrm>
          <a:prstGeom prst="rect">
            <a:avLst/>
          </a:prstGeom>
          <a:noFill/>
        </p:spPr>
        <p:txBody>
          <a:bodyPr wrap="square" lIns="98609" tIns="49304" rIns="98609" bIns="49304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11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43381" y="7041232"/>
            <a:ext cx="59436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11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. lycopersicum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indica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growth assay growth assay upon 200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nM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DL-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-(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Difluoromethy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arginine (DFMA) treatment. Visualization and quantification of (A) shoot and (B) root growth of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ontrol an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. indica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reated S. lycopersicum seedlings in presence and absence of DFM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n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7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o 10)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Quantification 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D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visualization of radial growth of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indica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upon 200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nM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DL-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-(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Difluoromethy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arginine (DFMA) treatment (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 = 5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.</a:t>
            </a:r>
          </a:p>
          <a:p>
            <a:pPr algn="just">
              <a:lnSpc>
                <a:spcPct val="150000"/>
              </a:lnSpc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5231998"/>
              </p:ext>
            </p:extLst>
          </p:nvPr>
        </p:nvGraphicFramePr>
        <p:xfrm>
          <a:off x="846775" y="4300466"/>
          <a:ext cx="2133600" cy="25785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70" r:id="rId3" imgW="2260397" imgH="2731008" progId="">
                  <p:embed/>
                </p:oleObj>
              </mc:Choice>
              <mc:Fallback>
                <p:oleObj r:id="rId3" imgW="2260397" imgH="2731008" progId="">
                  <p:embed/>
                  <p:pic>
                    <p:nvPicPr>
                      <p:cNvPr id="0" name="Picture 17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46775" y="4300466"/>
                        <a:ext cx="2133600" cy="2578599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2" name="Group 21"/>
          <p:cNvGrpSpPr/>
          <p:nvPr/>
        </p:nvGrpSpPr>
        <p:grpSpPr>
          <a:xfrm>
            <a:off x="3717032" y="4664968"/>
            <a:ext cx="2340722" cy="1456175"/>
            <a:chOff x="3505200" y="1518602"/>
            <a:chExt cx="2340722" cy="1456175"/>
          </a:xfrm>
        </p:grpSpPr>
        <p:pic>
          <p:nvPicPr>
            <p:cNvPr id="23" name="Picture 34" descr="D:\Anish\Tomato final data\Abhimanyu samples 2\Piri-Tomato manuscript\Figures\The Piri-tomato paper manuscript and document\IMG_20190712_113655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18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3505200" y="1518602"/>
              <a:ext cx="2340722" cy="14531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4" name="TextBox 23"/>
            <p:cNvSpPr txBox="1"/>
            <p:nvPr/>
          </p:nvSpPr>
          <p:spPr>
            <a:xfrm>
              <a:off x="3657600" y="2667000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solidFill>
                    <a:schemeClr val="bg1"/>
                  </a:solidFill>
                </a:rPr>
                <a:t>Control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707870" y="2667000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solidFill>
                    <a:schemeClr val="bg1"/>
                  </a:solidFill>
                </a:rPr>
                <a:t>DFMA</a:t>
              </a: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562132" y="4204166"/>
            <a:ext cx="423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6392067"/>
              </p:ext>
            </p:extLst>
          </p:nvPr>
        </p:nvGraphicFramePr>
        <p:xfrm>
          <a:off x="131763" y="1046902"/>
          <a:ext cx="3906837" cy="3179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71" r:id="rId7" imgW="3906720" imgH="3179520" progId="">
                  <p:embed/>
                </p:oleObj>
              </mc:Choice>
              <mc:Fallback>
                <p:oleObj r:id="rId7" imgW="3906720" imgH="3179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1763" y="1046902"/>
                        <a:ext cx="3906837" cy="3179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1373677"/>
              </p:ext>
            </p:extLst>
          </p:nvPr>
        </p:nvGraphicFramePr>
        <p:xfrm>
          <a:off x="3212976" y="1078686"/>
          <a:ext cx="3771146" cy="30945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72" r:id="rId9" imgW="3885120" imgH="3188160" progId="">
                  <p:embed/>
                </p:oleObj>
              </mc:Choice>
              <mc:Fallback>
                <p:oleObj r:id="rId9" imgW="3885120" imgH="31881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212976" y="1078686"/>
                        <a:ext cx="3771146" cy="30945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/>
          <p:cNvSpPr txBox="1"/>
          <p:nvPr/>
        </p:nvSpPr>
        <p:spPr>
          <a:xfrm>
            <a:off x="335752" y="905276"/>
            <a:ext cx="423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8" name="TextBox 37"/>
          <p:cNvSpPr txBox="1"/>
          <p:nvPr/>
        </p:nvSpPr>
        <p:spPr>
          <a:xfrm>
            <a:off x="3266622" y="905696"/>
            <a:ext cx="423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3439356" y="4232920"/>
            <a:ext cx="423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7316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52635" y="7924800"/>
            <a:ext cx="6552728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S12</a:t>
            </a:r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Importance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of putrescine on shoot and root growth of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. thaliana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during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P. indica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infestation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Quantification of Arabidopsis root length (n=12) upon 10 µM putrescine treatment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Verification of T-DNA insertion in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1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2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lines. Transcript accumulation of 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1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2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(upper lane)  and  housekeeping gene actin (lower lane) in wild type (WT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), adc1-2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 adc1-3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 adc2-3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 2-4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Schematic representation of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1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2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genes from Arabidopsis showing positions of T-DNA insertions.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1-2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1-3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has T-DNA insertions at 1496bp and 1100bp from the start codon respectively; whereas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2-3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dc2-4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have T-DNA insertions at 1301 and 98 bp from the start codon. Phenotypes of control and putrescine treated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A. thaliana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shoot. 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(D)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Growth promotion assay in putrescine biosynthetic mutants along with gain of function assay by putrescine supplementation. Values are mean ± SE of root growth. (n = 22 to 30).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47180" y="457200"/>
            <a:ext cx="2614579" cy="315015"/>
          </a:xfrm>
          <a:prstGeom prst="rect">
            <a:avLst/>
          </a:prstGeom>
          <a:noFill/>
        </p:spPr>
        <p:txBody>
          <a:bodyPr wrap="square" lIns="98609" tIns="49304" rIns="98609" bIns="49304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12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9837376"/>
              </p:ext>
            </p:extLst>
          </p:nvPr>
        </p:nvGraphicFramePr>
        <p:xfrm>
          <a:off x="1141250" y="1090394"/>
          <a:ext cx="1948755" cy="243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66" r:id="rId4" imgW="2225650" imgH="2930347" progId="">
                  <p:embed/>
                </p:oleObj>
              </mc:Choice>
              <mc:Fallback>
                <p:oleObj r:id="rId4" imgW="2225650" imgH="2930347" progId="">
                  <p:embed/>
                  <p:pic>
                    <p:nvPicPr>
                      <p:cNvPr id="0" name="Picture 10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41250" y="1090394"/>
                        <a:ext cx="1948755" cy="24384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Picture 11">
            <a:extLst>
              <a:ext uri="{FF2B5EF4-FFF2-40B4-BE49-F238E27FC236}">
                <a16:creationId xmlns="" xmlns:a16="http://schemas.microsoft.com/office/drawing/2014/main" id="{D95F5C69-80F2-4AD5-A1C9-EEA9F919D76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748046"/>
            <a:ext cx="5333999" cy="1299631"/>
          </a:xfrm>
          <a:prstGeom prst="rect">
            <a:avLst/>
          </a:prstGeom>
        </p:spPr>
      </p:pic>
      <p:pic>
        <p:nvPicPr>
          <p:cNvPr id="21" name="Picture 2"/>
          <p:cNvPicPr>
            <a:picLocks noChangeAspect="1" noChangeArrowheads="1"/>
          </p:cNvPicPr>
          <p:nvPr/>
        </p:nvPicPr>
        <p:blipFill>
          <a:blip r:embed="rId7"/>
          <a:srcRect l="41924" t="31257" r="25027" b="20816"/>
          <a:stretch>
            <a:fillRect/>
          </a:stretch>
        </p:blipFill>
        <p:spPr bwMode="auto">
          <a:xfrm>
            <a:off x="1852946" y="5326831"/>
            <a:ext cx="3177910" cy="25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2" name="Picture 21">
            <a:extLst>
              <a:ext uri="{FF2B5EF4-FFF2-40B4-BE49-F238E27FC236}">
                <a16:creationId xmlns="" xmlns:a16="http://schemas.microsoft.com/office/drawing/2014/main" id="{99C17753-7957-416E-8B08-C9090936E11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96" r="7189"/>
          <a:stretch/>
        </p:blipFill>
        <p:spPr>
          <a:xfrm>
            <a:off x="3505200" y="762000"/>
            <a:ext cx="2214238" cy="22098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762000" y="3563380"/>
            <a:ext cx="423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41232" y="906136"/>
            <a:ext cx="423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3266622" y="905696"/>
            <a:ext cx="423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633209" y="5375533"/>
            <a:ext cx="423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8965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839933" y="2286000"/>
            <a:ext cx="5308997" cy="3962400"/>
            <a:chOff x="685800" y="2503998"/>
            <a:chExt cx="5308997" cy="3962400"/>
          </a:xfrm>
        </p:grpSpPr>
        <p:pic>
          <p:nvPicPr>
            <p:cNvPr id="21506" name="Picture 2" descr="C:\Users\lab108\Downloads\Tomato pi 20X 90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5800" y="2503998"/>
              <a:ext cx="5308997" cy="3962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3" name="Straight Arrow Connector 2"/>
            <p:cNvCxnSpPr/>
            <p:nvPr/>
          </p:nvCxnSpPr>
          <p:spPr>
            <a:xfrm flipV="1">
              <a:off x="2743200" y="5018598"/>
              <a:ext cx="152400" cy="304800"/>
            </a:xfrm>
            <a:prstGeom prst="straightConnector1">
              <a:avLst/>
            </a:prstGeom>
            <a:ln w="50800">
              <a:solidFill>
                <a:srgbClr val="C00000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Arrow Connector 5"/>
            <p:cNvCxnSpPr/>
            <p:nvPr/>
          </p:nvCxnSpPr>
          <p:spPr>
            <a:xfrm flipV="1">
              <a:off x="1600200" y="4485198"/>
              <a:ext cx="152400" cy="304800"/>
            </a:xfrm>
            <a:prstGeom prst="straightConnector1">
              <a:avLst/>
            </a:prstGeom>
            <a:ln w="50800">
              <a:solidFill>
                <a:srgbClr val="C00000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 flipV="1">
              <a:off x="3505200" y="5323398"/>
              <a:ext cx="152400" cy="304800"/>
            </a:xfrm>
            <a:prstGeom prst="straightConnector1">
              <a:avLst/>
            </a:prstGeom>
            <a:ln w="50800">
              <a:solidFill>
                <a:srgbClr val="C00000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TextBox 10"/>
          <p:cNvSpPr txBox="1"/>
          <p:nvPr/>
        </p:nvSpPr>
        <p:spPr>
          <a:xfrm>
            <a:off x="609600" y="495300"/>
            <a:ext cx="32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Supporting Information Figure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24692" y="1905000"/>
            <a:ext cx="22250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upplemental Figure 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95582" y="6629400"/>
            <a:ext cx="53976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l Figure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1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rypan blue staining shows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indica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colonization in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S. lycopersicum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root after 10 days of co-cultivation. Arrow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ndicate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indic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pores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cale bar is 50 µm.</a:t>
            </a:r>
          </a:p>
        </p:txBody>
      </p:sp>
    </p:spTree>
    <p:extLst>
      <p:ext uri="{BB962C8B-B14F-4D97-AF65-F5344CB8AC3E}">
        <p14:creationId xmlns:p14="http://schemas.microsoft.com/office/powerpoint/2010/main" val="87367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42742" y="371901"/>
            <a:ext cx="5482929" cy="7372698"/>
            <a:chOff x="676767" y="1651000"/>
            <a:chExt cx="5482929" cy="7372698"/>
          </a:xfrm>
        </p:grpSpPr>
        <p:sp>
          <p:nvSpPr>
            <p:cNvPr id="7" name="TextBox 6"/>
            <p:cNvSpPr txBox="1"/>
            <p:nvPr/>
          </p:nvSpPr>
          <p:spPr>
            <a:xfrm>
              <a:off x="700453" y="1651000"/>
              <a:ext cx="22585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Supplemental Figure S2</a:t>
              </a: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676767" y="1958777"/>
              <a:ext cx="2839326" cy="1701131"/>
              <a:chOff x="524368" y="2659124"/>
              <a:chExt cx="2839326" cy="1701131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984357" y="2851280"/>
                <a:ext cx="2379337" cy="1508975"/>
                <a:chOff x="-549369" y="3586867"/>
                <a:chExt cx="2751406" cy="1655013"/>
              </a:xfrm>
            </p:grpSpPr>
            <p:pic>
              <p:nvPicPr>
                <p:cNvPr id="7170" name="Picture 2" descr="C:\Users\lab108\Downloads\INTEX ELYT E1_20180428_130341.jpg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-549369" y="3586867"/>
                  <a:ext cx="2751406" cy="165501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6" name="TextBox 5"/>
                <p:cNvSpPr txBox="1"/>
                <p:nvPr/>
              </p:nvSpPr>
              <p:spPr>
                <a:xfrm>
                  <a:off x="25892" y="3671484"/>
                  <a:ext cx="1371598" cy="4050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30 dpi</a:t>
                  </a:r>
                </a:p>
              </p:txBody>
            </p:sp>
          </p:grpSp>
          <p:sp>
            <p:nvSpPr>
              <p:cNvPr id="15" name="TextBox 14"/>
              <p:cNvSpPr txBox="1"/>
              <p:nvPr/>
            </p:nvSpPr>
            <p:spPr>
              <a:xfrm>
                <a:off x="524368" y="2659124"/>
                <a:ext cx="45998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/>
                  <a:t>A</a:t>
                </a:r>
                <a:endParaRPr lang="en-US" dirty="0"/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761998" y="7546370"/>
              <a:ext cx="5397698" cy="1477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ct val="150000"/>
                </a:lnSpc>
              </a:pP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Supplemental 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Figure </a:t>
              </a: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S2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Different phenotypic changes and growth induction of 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S. lycopersicum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upon 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P. indica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 colonization. 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(A)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Visual 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differences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in 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S. lycopersicum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growth after 30 dpi. Effect of 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P. indica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treatment after on 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(B)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shoot length, 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(C)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root length and of 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S. lycopersicum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after 40 dpi. Significance analysis was done by unpaired 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t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-test; **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&lt;0.01, ***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&lt;0.001.  </a:t>
              </a: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482068" y="674301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2960353"/>
              </p:ext>
            </p:extLst>
          </p:nvPr>
        </p:nvGraphicFramePr>
        <p:xfrm>
          <a:off x="3712062" y="620076"/>
          <a:ext cx="2231537" cy="2656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896" r:id="rId4" imgW="2492654" imgH="2966314" progId="">
                  <p:embed/>
                </p:oleObj>
              </mc:Choice>
              <mc:Fallback>
                <p:oleObj r:id="rId4" imgW="2492654" imgH="2966314" progId="">
                  <p:embed/>
                  <p:pic>
                    <p:nvPicPr>
                      <p:cNvPr id="0" name="Picture 49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12062" y="620076"/>
                        <a:ext cx="2231537" cy="2656524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4939624"/>
              </p:ext>
            </p:extLst>
          </p:nvPr>
        </p:nvGraphicFramePr>
        <p:xfrm>
          <a:off x="845799" y="3153953"/>
          <a:ext cx="2439706" cy="28658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897" r:id="rId6" imgW="2545080" imgH="2965704" progId="">
                  <p:embed/>
                </p:oleObj>
              </mc:Choice>
              <mc:Fallback>
                <p:oleObj r:id="rId6" imgW="2545080" imgH="2965704" progId="">
                  <p:embed/>
                  <p:pic>
                    <p:nvPicPr>
                      <p:cNvPr id="0" name="Picture 49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45799" y="3153953"/>
                        <a:ext cx="2439706" cy="286584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708496" y="3103224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04240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1472" y="455711"/>
            <a:ext cx="21719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l Figure  S3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873718" y="3394758"/>
            <a:ext cx="9797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Leaf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680098" y="3366700"/>
            <a:ext cx="9797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Roo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04142" y="3873876"/>
            <a:ext cx="602484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3</a:t>
            </a:r>
          </a:p>
          <a:p>
            <a:pPr algn="just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earson’s correlation of metabolite alteration in leaf and root. (A)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earson’s correlation co-efficient (PCC) analysis among 55 annotated leaf metabolites of control an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. indica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reated tomato plants based on the normalized value of GC-MS peak area. (B) Pearson’s correlation co-efficient (PCC) analysis among 70 annotated root metabolites of control an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. indic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reated tomato plants based on the normalized value of GC-MS peak area. Normalization was done with the peak area of internal standard (ribitol).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34003" y="904818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516566" y="904818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5650" y="993665"/>
            <a:ext cx="5041829" cy="23837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65724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7073533"/>
              </p:ext>
            </p:extLst>
          </p:nvPr>
        </p:nvGraphicFramePr>
        <p:xfrm>
          <a:off x="3048000" y="1371600"/>
          <a:ext cx="3295650" cy="243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83" r:id="rId3" imgW="4080662" imgH="2974238" progId="">
                  <p:embed/>
                </p:oleObj>
              </mc:Choice>
              <mc:Fallback>
                <p:oleObj r:id="rId3" imgW="4080662" imgH="2974238" progId="">
                  <p:embed/>
                  <p:pic>
                    <p:nvPicPr>
                      <p:cNvPr id="0" name="Picture 3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48000" y="1371600"/>
                        <a:ext cx="3295650" cy="24384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5606489"/>
              </p:ext>
            </p:extLst>
          </p:nvPr>
        </p:nvGraphicFramePr>
        <p:xfrm>
          <a:off x="3048000" y="3657600"/>
          <a:ext cx="3352800" cy="2455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84" r:id="rId5" imgW="4387901" imgH="3177845" progId="">
                  <p:embed/>
                </p:oleObj>
              </mc:Choice>
              <mc:Fallback>
                <p:oleObj r:id="rId5" imgW="4387901" imgH="3177845" progId="">
                  <p:embed/>
                  <p:pic>
                    <p:nvPicPr>
                      <p:cNvPr id="0" name="Picture 3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48000" y="3657600"/>
                        <a:ext cx="3352800" cy="245586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98351" y="1245781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118884" y="1251465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971800" y="3810000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79190" y="371900"/>
            <a:ext cx="28337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ure S4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79191" y="6324600"/>
            <a:ext cx="6021609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4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lteration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f leaf metabolites in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S. lycopersicum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upon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indica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reatment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Volcano plot show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up-regulation of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ve metabolites (red dots) and down regulation of four metabolite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blue dot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in leaf. Point denoted as 1 shows maximum up-regulation representing 12-hydroxybutyric acid. Mean ± SE of normalized responses of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up-regulated 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down-regulated metabolites in leaf. Three biological replicates were taken for each analysis and each biological replicate was a pool of three individually harvested samples. Significant analysis was done by unpaired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test;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*P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&lt;0.05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**P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&lt;0.001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***P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&lt;0.0001.</a:t>
            </a:r>
            <a:endParaRPr lang="en-US" sz="1200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5108" y="1184152"/>
            <a:ext cx="2481948" cy="2520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5516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6543858"/>
              </p:ext>
            </p:extLst>
          </p:nvPr>
        </p:nvGraphicFramePr>
        <p:xfrm>
          <a:off x="674271" y="2975160"/>
          <a:ext cx="4391352" cy="2793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662" r:id="rId3" imgW="5059070" imgH="3279648" progId="">
                  <p:embed/>
                </p:oleObj>
              </mc:Choice>
              <mc:Fallback>
                <p:oleObj r:id="rId3" imgW="5059070" imgH="3279648" progId="">
                  <p:embed/>
                  <p:pic>
                    <p:nvPicPr>
                      <p:cNvPr id="0" name="Picture 16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4271" y="2975160"/>
                        <a:ext cx="4391352" cy="279385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379190" y="371900"/>
            <a:ext cx="25457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5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61784" y="7746211"/>
            <a:ext cx="6552728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S5</a:t>
            </a:r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S. Lycopersicum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root metabolites alteration upon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. indica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colonization (40 dpi). (A) Up and (B) Down-regulated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root metabolites upon 40 dpi of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P. indica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inoculation. Mean ± SE (n = 3) of normalized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responses (normalization was done with the internal standard,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ribitol’s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peak area)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of the metabolites significantly altered in the root upon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P. indica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colonization. Numbers are indicating the points in the volcano plot provided in Fig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3A.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Significance analysis was done by unpaired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-test;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*P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&lt;0.05, **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&lt;0.01, ***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&lt;0.001, ***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&lt;0.0001. 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-plot form OPLS-DA </a:t>
            </a:r>
            <a:r>
              <a:rPr lang="en-US" sz="11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odel of 77 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root metabolite’s normalized peak areas in control and </a:t>
            </a:r>
            <a:r>
              <a:rPr lang="en-US" sz="11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. indica 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reated root samples. Red arrow in zoomed plot indicates putrescine with highest reliability and magnitude. 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11650"/>
              </p:ext>
            </p:extLst>
          </p:nvPr>
        </p:nvGraphicFramePr>
        <p:xfrm>
          <a:off x="1405791" y="643869"/>
          <a:ext cx="3672408" cy="25858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663" r:id="rId5" imgW="4061765" imgH="2899867" progId="">
                  <p:embed/>
                </p:oleObj>
              </mc:Choice>
              <mc:Fallback>
                <p:oleObj r:id="rId5" imgW="4061765" imgH="2899867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05791" y="643869"/>
                        <a:ext cx="3672408" cy="2585881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110773" y="883223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110773" y="3316553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198223" y="5658232"/>
            <a:ext cx="45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2147915" y="5842898"/>
            <a:ext cx="2780465" cy="1404978"/>
            <a:chOff x="1052736" y="1784648"/>
            <a:chExt cx="2780465" cy="1404978"/>
          </a:xfrm>
        </p:grpSpPr>
        <p:grpSp>
          <p:nvGrpSpPr>
            <p:cNvPr id="20" name="Group 19"/>
            <p:cNvGrpSpPr/>
            <p:nvPr/>
          </p:nvGrpSpPr>
          <p:grpSpPr>
            <a:xfrm>
              <a:off x="1052736" y="1784648"/>
              <a:ext cx="2780465" cy="1404978"/>
              <a:chOff x="3489995" y="3379095"/>
              <a:chExt cx="2780465" cy="1404978"/>
            </a:xfrm>
          </p:grpSpPr>
          <p:pic>
            <p:nvPicPr>
              <p:cNvPr id="23" name="Picture 22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947513" y="3401826"/>
                <a:ext cx="1322947" cy="932769"/>
              </a:xfrm>
              <a:prstGeom prst="rect">
                <a:avLst/>
              </a:prstGeom>
            </p:spPr>
          </p:pic>
          <p:grpSp>
            <p:nvGrpSpPr>
              <p:cNvPr id="24" name="Group 23"/>
              <p:cNvGrpSpPr/>
              <p:nvPr/>
            </p:nvGrpSpPr>
            <p:grpSpPr>
              <a:xfrm>
                <a:off x="3489995" y="3379095"/>
                <a:ext cx="2764675" cy="1404978"/>
                <a:chOff x="3489995" y="3379095"/>
                <a:chExt cx="2764675" cy="1404978"/>
              </a:xfrm>
            </p:grpSpPr>
            <p:pic>
              <p:nvPicPr>
                <p:cNvPr id="25" name="Picture 24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489995" y="3379095"/>
                  <a:ext cx="1468044" cy="1404978"/>
                </a:xfrm>
                <a:prstGeom prst="rect">
                  <a:avLst/>
                </a:prstGeom>
              </p:spPr>
            </p:pic>
            <p:sp>
              <p:nvSpPr>
                <p:cNvPr id="26" name="Rectangle 25"/>
                <p:cNvSpPr/>
                <p:nvPr/>
              </p:nvSpPr>
              <p:spPr>
                <a:xfrm>
                  <a:off x="4572780" y="3621845"/>
                  <a:ext cx="224372" cy="107020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7" name="Straight Connector 26"/>
                <p:cNvCxnSpPr/>
                <p:nvPr/>
              </p:nvCxnSpPr>
              <p:spPr>
                <a:xfrm flipV="1">
                  <a:off x="4789337" y="3410712"/>
                  <a:ext cx="165083" cy="217639"/>
                </a:xfrm>
                <a:prstGeom prst="line">
                  <a:avLst/>
                </a:prstGeom>
                <a:ln w="31750">
                  <a:solidFill>
                    <a:srgbClr val="274467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/>
                <p:cNvCxnSpPr/>
                <p:nvPr/>
              </p:nvCxnSpPr>
              <p:spPr>
                <a:xfrm>
                  <a:off x="4797152" y="3728865"/>
                  <a:ext cx="157268" cy="605730"/>
                </a:xfrm>
                <a:prstGeom prst="line">
                  <a:avLst/>
                </a:prstGeom>
                <a:ln w="31750">
                  <a:solidFill>
                    <a:srgbClr val="274467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Rectangle 28"/>
                <p:cNvSpPr/>
                <p:nvPr/>
              </p:nvSpPr>
              <p:spPr>
                <a:xfrm>
                  <a:off x="4950224" y="3400305"/>
                  <a:ext cx="1304446" cy="934290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21" name="TextBox 20"/>
            <p:cNvSpPr txBox="1"/>
            <p:nvPr/>
          </p:nvSpPr>
          <p:spPr>
            <a:xfrm>
              <a:off x="2691975" y="1784648"/>
              <a:ext cx="970030" cy="2391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/>
                <a:t>Putrescine</a:t>
              </a:r>
              <a:endParaRPr lang="en-US" sz="900" dirty="0"/>
            </a:p>
          </p:txBody>
        </p:sp>
        <p:cxnSp>
          <p:nvCxnSpPr>
            <p:cNvPr id="22" name="Straight Arrow Connector 21"/>
            <p:cNvCxnSpPr/>
            <p:nvPr/>
          </p:nvCxnSpPr>
          <p:spPr>
            <a:xfrm>
              <a:off x="3257793" y="2003891"/>
              <a:ext cx="157421" cy="82143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037517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55674" y="5181600"/>
            <a:ext cx="60198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2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6</a:t>
            </a:r>
            <a:endParaRPr lang="en-US" sz="12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  <a:p>
            <a:pPr lvl="0" algn="just">
              <a:lnSpc>
                <a:spcPct val="1500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catter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lot of pathway impact in root shows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pecific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etabolism in root affected by </a:t>
            </a:r>
            <a:r>
              <a:rPr lang="en-US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. indica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colonization.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55674" y="757535"/>
            <a:ext cx="5034643" cy="330403"/>
          </a:xfrm>
          <a:prstGeom prst="rect">
            <a:avLst/>
          </a:prstGeom>
          <a:noFill/>
        </p:spPr>
        <p:txBody>
          <a:bodyPr wrap="square" lIns="98609" tIns="49304" rIns="98609" bIns="49304" rtlCol="0">
            <a:spAutoFit/>
          </a:bodyPr>
          <a:lstStyle/>
          <a:p>
            <a:pPr algn="just"/>
            <a:r>
              <a:rPr lang="en-US" sz="15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S6</a:t>
            </a:r>
            <a:endParaRPr lang="en-US" sz="15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9430" y="1496616"/>
            <a:ext cx="4420887" cy="3612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35795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7604053"/>
              </p:ext>
            </p:extLst>
          </p:nvPr>
        </p:nvGraphicFramePr>
        <p:xfrm>
          <a:off x="2000240" y="2166918"/>
          <a:ext cx="2781085" cy="33575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851" r:id="rId3" imgW="2481682" imgH="2995574" progId="">
                  <p:embed/>
                </p:oleObj>
              </mc:Choice>
              <mc:Fallback>
                <p:oleObj r:id="rId3" imgW="2481682" imgH="2995574" progId="">
                  <p:embed/>
                  <p:pic>
                    <p:nvPicPr>
                      <p:cNvPr id="0" name="Picture 36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00240" y="2166918"/>
                        <a:ext cx="2781085" cy="3357586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561481" y="426816"/>
            <a:ext cx="2614579" cy="315015"/>
          </a:xfrm>
          <a:prstGeom prst="rect">
            <a:avLst/>
          </a:prstGeom>
          <a:noFill/>
        </p:spPr>
        <p:txBody>
          <a:bodyPr wrap="square" lIns="98609" tIns="49304" rIns="98609" bIns="49304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7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581518" y="6768405"/>
            <a:ext cx="5819281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2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7</a:t>
            </a:r>
            <a:endParaRPr lang="en-US" sz="12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ffect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f 10 µM putrescine on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hoot length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200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 lycopersicum.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Quantification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hoot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length upon 10 µM putrescine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reatment (added to the MS media) on 5 day old seedling (n = 10). The shoot length was measured after 21 day of treatment. Significant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nalysis was done by unpaired </a:t>
            </a:r>
            <a:r>
              <a:rPr lang="en-US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test;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****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&lt;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0.0001.</a:t>
            </a:r>
            <a:endParaRPr lang="en-US" sz="1200" dirty="0"/>
          </a:p>
          <a:p>
            <a:pPr lvl="0" algn="just">
              <a:lnSpc>
                <a:spcPct val="150000"/>
              </a:lnSpc>
            </a:pPr>
            <a:endParaRPr lang="en-US" sz="1200" i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4345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320049" y="249667"/>
            <a:ext cx="2614579" cy="315015"/>
          </a:xfrm>
          <a:prstGeom prst="rect">
            <a:avLst/>
          </a:prstGeom>
          <a:noFill/>
        </p:spPr>
        <p:txBody>
          <a:bodyPr wrap="square" lIns="98609" tIns="49304" rIns="98609" bIns="49304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8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559496" y="7696200"/>
            <a:ext cx="556259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l Figure 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8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ffect of putrescine on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. indica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rowth. (A)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v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different putrescine concentrations (5 µM-100 µM) and their effects on the radial growth of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indica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ach value indicates mean ± SE (n=10). Significant analysis was done by unpaired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test and different letters indicate significan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ifferences (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&lt;0.05).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ffect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f 10 µM putrescine on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(B) dry and (C) fresh biomass of </a:t>
            </a:r>
            <a:r>
              <a:rPr lang="en-US" sz="1200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200" i="1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ndica</a:t>
            </a:r>
            <a:r>
              <a:rPr lang="en-US" sz="1200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ycelia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&lt;0.05, ***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&lt;0.001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7779012"/>
              </p:ext>
            </p:extLst>
          </p:nvPr>
        </p:nvGraphicFramePr>
        <p:xfrm>
          <a:off x="1627338" y="877662"/>
          <a:ext cx="2953789" cy="3027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730" r:id="rId3" imgW="2578608" imgH="2840126" progId="">
                  <p:embed/>
                </p:oleObj>
              </mc:Choice>
              <mc:Fallback>
                <p:oleObj r:id="rId3" imgW="2578608" imgH="2840126" progId="">
                  <p:embed/>
                  <p:pic>
                    <p:nvPicPr>
                      <p:cNvPr id="0" name="Picture 31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27338" y="877662"/>
                        <a:ext cx="2953789" cy="3027737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5416004"/>
              </p:ext>
            </p:extLst>
          </p:nvPr>
        </p:nvGraphicFramePr>
        <p:xfrm>
          <a:off x="599242" y="4429125"/>
          <a:ext cx="2582873" cy="28959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731" r:id="rId5" imgW="2545080" imgH="2939491" progId="">
                  <p:embed/>
                </p:oleObj>
              </mc:Choice>
              <mc:Fallback>
                <p:oleObj r:id="rId5" imgW="2545080" imgH="2939491" progId="">
                  <p:embed/>
                  <p:pic>
                    <p:nvPicPr>
                      <p:cNvPr id="0" name="Picture 32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9242" y="4429125"/>
                        <a:ext cx="2582873" cy="2895948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9233169"/>
              </p:ext>
            </p:extLst>
          </p:nvPr>
        </p:nvGraphicFramePr>
        <p:xfrm>
          <a:off x="3810000" y="4429125"/>
          <a:ext cx="2554210" cy="28955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732" r:id="rId7" imgW="2613355" imgH="2961437" progId="">
                  <p:embed/>
                </p:oleObj>
              </mc:Choice>
              <mc:Fallback>
                <p:oleObj r:id="rId7" imgW="2613355" imgH="2961437" progId="">
                  <p:embed/>
                  <p:pic>
                    <p:nvPicPr>
                      <p:cNvPr id="0" name="Picture 32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10000" y="4429125"/>
                        <a:ext cx="2554210" cy="2895599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377305" y="751492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  <a:endParaRPr lang="en-IN" dirty="0"/>
          </a:p>
        </p:txBody>
      </p:sp>
      <p:sp>
        <p:nvSpPr>
          <p:cNvPr id="9" name="TextBox 8"/>
          <p:cNvSpPr txBox="1"/>
          <p:nvPr/>
        </p:nvSpPr>
        <p:spPr>
          <a:xfrm>
            <a:off x="214290" y="4452934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IN" dirty="0"/>
          </a:p>
        </p:txBody>
      </p:sp>
      <p:sp>
        <p:nvSpPr>
          <p:cNvPr id="11" name="TextBox 10"/>
          <p:cNvSpPr txBox="1"/>
          <p:nvPr/>
        </p:nvSpPr>
        <p:spPr>
          <a:xfrm>
            <a:off x="3391410" y="4484368"/>
            <a:ext cx="428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3684911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44</TotalTime>
  <Words>1327</Words>
  <Application>Microsoft Office PowerPoint</Application>
  <PresentationFormat>A4 Paper (210x297 mm)</PresentationFormat>
  <Paragraphs>87</Paragraphs>
  <Slides>13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Times New Roman</vt:lpstr>
      <vt:lpstr>Office Theme</vt:lpstr>
      <vt:lpstr>  Supporting Information for  Piriformospora indica employs host’s putrescine for growth promotion in plants   Anish Kundu, Abhimanyu Jogawat, Shruti Mishra, Pritha Kundu, Jyothilakshmi Vadassery*  *Correspondence to:  jyothi.v@nipgr.ac.in 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108</dc:creator>
  <cp:lastModifiedBy>Windows User</cp:lastModifiedBy>
  <cp:revision>412</cp:revision>
  <dcterms:created xsi:type="dcterms:W3CDTF">2018-05-02T07:39:44Z</dcterms:created>
  <dcterms:modified xsi:type="dcterms:W3CDTF">2020-12-15T13:13:00Z</dcterms:modified>
</cp:coreProperties>
</file>